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5BF212-7119-41CC-B324-C8EE19578B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50A4DD-E3BB-4141-8ECD-8FC3F5D4EB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CBCACD-C82B-46FC-82B5-25F20A5480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FE476-C69A-461F-84B3-1C4B1E2ED0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0199A3-2098-471F-AA84-59D54E18A1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FF890-58D2-47E3-823E-FE19EEAB06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3C339-EFA3-4390-982D-FEFCCC06E5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C1A3C-7838-42DE-8296-3B481261A9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9D7534-B8D0-4BBF-A0EA-1CD5586CB2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4C51C7-7228-4514-842E-6EAA5D790D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AB27F-8866-4209-85CF-F89F364E38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F521E-A41A-436F-ADBD-625B71931C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5A1F1CE-7CD4-4F9F-9269-59BB75735B02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3" descr="スクリーンショット（2012-03-19 12.29.48）.png"/>
          <p:cNvPicPr/>
          <p:nvPr/>
        </p:nvPicPr>
        <p:blipFill>
          <a:blip r:embed="rId1"/>
          <a:stretch/>
        </p:blipFill>
        <p:spPr>
          <a:xfrm>
            <a:off x="1054080" y="808200"/>
            <a:ext cx="6831000" cy="4844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2" name="テキスト ボックス 6"/>
          <p:cNvSpPr/>
          <p:nvPr/>
        </p:nvSpPr>
        <p:spPr>
          <a:xfrm>
            <a:off x="7697520" y="6473880"/>
            <a:ext cx="131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gure 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テキスト ボックス 2"/>
          <p:cNvSpPr/>
          <p:nvPr/>
        </p:nvSpPr>
        <p:spPr>
          <a:xfrm>
            <a:off x="321480" y="357120"/>
            <a:ext cx="848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IF analysis of  molecular network of downregulated genes in U373MG cells following exposure to ET-770, the compound 1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テキスト ボックス 1"/>
          <p:cNvSpPr/>
          <p:nvPr/>
        </p:nvSpPr>
        <p:spPr>
          <a:xfrm>
            <a:off x="936720" y="5773680"/>
            <a:ext cx="7137360" cy="550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e performed the impact factor (IF) analysis by using the Pathway Express tool. The analysis indicated that adherence junction (hsa04520) (IF = 29.856) shown above and phosphatidylinositol signaling system (hsa04070) (IF = 26.696) represented the pathways exhibiting the greatest impact on the set of downregulated genes in U373MG cells by the compound 1a.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9T04:40:08Z</dcterms:created>
  <dc:creator>Satoh Jun-ichi</dc:creator>
  <dc:description/>
  <dc:language>en-US</dc:language>
  <cp:lastModifiedBy>Satoh Jun-ichi</cp:lastModifiedBy>
  <dcterms:modified xsi:type="dcterms:W3CDTF">2012-03-31T05:41:00Z</dcterms:modified>
  <cp:revision>7</cp:revision>
  <dc:subject/>
  <dc:title>PowerPoint プレゼンテーション</dc:title>
</cp:coreProperties>
</file>